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17" d="100"/>
          <a:sy n="117" d="100"/>
        </p:scale>
        <p:origin x="8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166A8F-8171-A46B-4293-E7BA45BCC1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ED9F662-729E-BFBA-17B9-94EF2683A4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C409ED-F285-CC3D-D67A-7F0A1E446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D4757C-816E-7D61-4E43-E17B934F0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1D13E9-099E-95D9-CFAA-99B3437CC1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356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C2788B-5893-7890-D72E-4FB1F1ED3C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CE823F-31D4-CB9C-E2F1-1091019F86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D00D5A-36A2-3672-2F47-D2B354BE9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19F0C5-A39F-FC05-7023-E61D6E725F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32E95C-EE6B-11FC-1622-D6EFFA7B6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500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EBC6FC-CFCA-BD98-6FE4-33A559F9C2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C62886-E42B-DAC2-00F7-8DAA2F250F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84520A-75FF-1C12-529F-B9C9F3CC3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333873-8DD3-B8AD-45A6-9DFA63DF6A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BAA7FA-84C7-A5FF-330C-0689359594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915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292B7F-0441-BCF1-D594-A25739C40B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FC9CD1-129E-BA98-FCD3-87F8F866554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C68955-2778-6ECF-BCD5-93D3A3999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EEF5CF-8321-2C9F-A374-041CE624B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359722-B3D6-9187-57D2-FE95FD2871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34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252B02-98F8-9DB4-BC15-AAEFE8B3F7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44CBC9-F4FB-E3E1-8067-981DD2C2B5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6568BE-F489-644C-81CE-B3FF8B7BE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CF96-1E36-6683-AAD8-5E68AA1F0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CBB75B-0797-B54A-2978-CB9C4B2C0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2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C8D31-E834-71D0-2F6C-5CE1442257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472A55-CBEA-B6C1-FAFD-FBB747329F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4D95CC-2AA9-8C2F-033C-766F89D7F6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9D3206-F220-ECD2-0EB8-CC4997131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C984B6-A783-3307-D3F7-F78802201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C9A44D-4B33-8FA2-3871-3EFDCB6A7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230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63CA2D-A54E-7257-22B4-8C7A15B562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A2CCEE-15AD-12FF-4B2F-39304E7666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F211CB-8347-1CD7-D059-834463D63C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3BC8C0F-709D-B975-7BDE-D86592D935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A9601E6-8674-FF8A-29FB-E76722EE33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8D8470D-20CF-3DE3-E77A-E837A03F3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2D3EFA9-733A-4D92-4032-1219DBBE0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63A702C-D572-7BD7-98D5-8A4C061FC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8824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C41DDA-4D04-16A2-1DF6-D9E3B9189B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861A45D-3654-B404-497A-5121570271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1DE0474-976E-5703-2B84-406ECB3F3C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B0C419-3D88-61AF-9A67-7A97A53F8C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601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2BBB9D6-2310-FDD5-F65B-5CA72E86F6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3EA328-039F-AC01-7AD8-6E9A7B2C6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000896-B591-7B9D-0C86-789432BB27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942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A13D26-61D5-463D-B180-9B924BD402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60DA4D-B02B-F215-F921-5DCDCACCD5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5048AD-9946-422A-36D0-C7544BAF27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BDE559-5A24-37F7-9396-9733D6D80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16AFEA-2A71-B8B4-893A-FD5FC19086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3EDDC3-5C78-3B7D-9967-9D61323E1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486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350F8A-19CE-6C3B-058E-3A06DDA0C2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5551325-DD43-A0F7-D60F-10F5B6AFA6E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A5B584-CD81-ACCB-65D7-BAC7E84655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37B649-DAB4-BCF1-4AB2-E9E2493FD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66A01A-AC43-6948-573C-C120FF5EE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7A928A-F6A1-3FF5-42AB-A33D318F1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5338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449213F-2933-5A5A-8165-D21AA3AA99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5C3692-D79B-47DD-E7BC-4897D0B9B4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2F04F5-B3D2-2E52-62F0-DA6677C36F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CDB4CB-A2ED-0E4D-B403-954443A50523}" type="datetimeFigureOut">
              <a:rPr lang="en-US" smtClean="0"/>
              <a:t>8/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C99FC9-E558-CB9D-3313-1C31EE7834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6BE832-BF8A-3641-FEEF-78A79FF427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796F79C-990B-994B-BCF3-ACD888F9C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382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964C205-F5A9-27BF-AA1E-6B851429D8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2147" y="0"/>
            <a:ext cx="7127706" cy="530465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BBA9017-A723-4374-5954-371BE491CC4F}"/>
              </a:ext>
            </a:extLst>
          </p:cNvPr>
          <p:cNvSpPr txBox="1"/>
          <p:nvPr/>
        </p:nvSpPr>
        <p:spPr>
          <a:xfrm>
            <a:off x="272143" y="5204225"/>
            <a:ext cx="11647714" cy="16158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buNone/>
            </a:pPr>
            <a:r>
              <a:rPr lang="en-US" sz="11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l Figure 1. Evaluation of overall survival based on DRD2 and DRD3 signatures in invasive breast cancer patients.</a:t>
            </a:r>
            <a:endParaRPr lang="en-US" sz="1100" dirty="0"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 algn="just">
              <a:buNone/>
            </a:pPr>
            <a:r>
              <a:rPr lang="en-US" sz="11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sz="1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Kaplan-Meier analysis of overall survival (OS) in invasive breast cancer patients stratified by DRD2 mRNA expression levels. The red line represents patients with down-regulated DRD2 expression, while the blue line indicates those with unchanged expression. OS in the DRD2 down-regulated subgroup was not significantly different from the unchanged group (log-rank test, </a:t>
            </a:r>
            <a:r>
              <a:rPr lang="en-US" sz="1100" i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=0.801). The number of patients at risk is displayed below the Kaplan-Meier curve. </a:t>
            </a:r>
            <a:r>
              <a:rPr lang="en-US" sz="11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B) </a:t>
            </a:r>
            <a:r>
              <a:rPr lang="en-US" sz="1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mmary table showing the total number of cases, deceased cases, and median survival of patients with either downregulated or unchanged DRD2 expression.</a:t>
            </a:r>
            <a:r>
              <a:rPr lang="en-US" sz="11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(C)</a:t>
            </a:r>
            <a:r>
              <a:rPr lang="en-US" sz="1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Kaplan-Meier analysis of overall survival (OS) in invasive breast cancer patients stratified by DRD3 mRNA expression levels. The red line represents patients with down-regulated DRD3 expression, while the blue line indicates those with unchanged expression. OS in the DRD3 down-regulated subgroup was not significantly different from the unchanged group (log-rank test, </a:t>
            </a:r>
            <a:r>
              <a:rPr lang="en-US" sz="1100" i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=0.178). The number of patients at risk is displayed below the Kaplan-Meier curve. </a:t>
            </a:r>
            <a:r>
              <a:rPr lang="en-US" sz="11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D) </a:t>
            </a:r>
            <a:r>
              <a:rPr lang="en-US" sz="11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mmary table showing the total number of cases, deceased cases, and median survival of patients with either downregulated or unchanged DRD3 expression.</a:t>
            </a:r>
            <a:r>
              <a:rPr lang="en-US" sz="11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2137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32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e, Ling</dc:creator>
  <cp:lastModifiedBy>He, Ling</cp:lastModifiedBy>
  <cp:revision>1</cp:revision>
  <dcterms:created xsi:type="dcterms:W3CDTF">2025-08-07T04:35:47Z</dcterms:created>
  <dcterms:modified xsi:type="dcterms:W3CDTF">2025-08-07T04:37:26Z</dcterms:modified>
</cp:coreProperties>
</file>